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256" r:id="rId2"/>
    <p:sldId id="261" r:id="rId3"/>
    <p:sldId id="264" r:id="rId4"/>
  </p:sldIdLst>
  <p:sldSz cx="12192000" cy="6858000"/>
  <p:notesSz cx="6858000" cy="99456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6C63957C-44D1-43A9-8604-1294DF331F9F}"/>
              </a:ext>
            </a:extLst>
          </p:cNvPr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2971800" cy="49901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200" b="0" i="0" u="none" strike="noStrike" kern="1200" cap="none" spc="0" baseline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6CB67E5-1BAF-4DDD-B5B5-B8B8578AB3D4}"/>
              </a:ext>
            </a:extLst>
          </p:cNvPr>
          <p:cNvSpPr txBox="1">
            <a:spLocks noGrp="1"/>
          </p:cNvSpPr>
          <p:nvPr>
            <p:ph type="dt" sz="quarter" idx="1"/>
          </p:nvPr>
        </p:nvSpPr>
        <p:spPr>
          <a:xfrm>
            <a:off x="3884608" y="0"/>
            <a:ext cx="2971800" cy="49901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fld id="{BE7A81A3-BC21-4B94-83EB-1BBAB9D8D723}" type="datetime1">
              <a: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pPr marL="0" marR="0" lvl="0" indent="0" algn="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t>18/05/2018</a:t>
            </a:fld>
            <a:endParaRPr lang="en-GB" sz="1200" b="0" i="0" u="none" strike="noStrike" kern="1200" cap="none" spc="0" baseline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7676402-BA46-4E81-A34E-FD0447DC08EC}"/>
              </a:ext>
            </a:extLst>
          </p:cNvPr>
          <p:cNvSpPr txBox="1">
            <a:spLocks noGrp="1"/>
          </p:cNvSpPr>
          <p:nvPr>
            <p:ph type="ftr" sz="quarter" idx="2"/>
          </p:nvPr>
        </p:nvSpPr>
        <p:spPr>
          <a:xfrm>
            <a:off x="0" y="9446675"/>
            <a:ext cx="2971800" cy="49901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b" anchorCtr="0" compatLnSpc="1">
            <a:no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200" b="0" i="0" u="none" strike="noStrike" kern="1200" cap="none" spc="0" baseline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524DDEC-EFB4-4AF6-A96B-BD65E6A95773}"/>
              </a:ext>
            </a:extLst>
          </p:cNvPr>
          <p:cNvSpPr txBox="1">
            <a:spLocks noGrp="1"/>
          </p:cNvSpPr>
          <p:nvPr>
            <p:ph type="sldNum" sz="quarter" idx="3"/>
          </p:nvPr>
        </p:nvSpPr>
        <p:spPr>
          <a:xfrm>
            <a:off x="3884608" y="9446675"/>
            <a:ext cx="2971800" cy="49901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b" anchorCtr="0" compatLnSpc="1">
            <a:noAutofit/>
          </a:bodyPr>
          <a:lstStyle/>
          <a:p>
            <a: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fld id="{3DC34545-0827-4695-9545-1DDFF17F1DC4}" type="slidenum">
              <a:t>‹#›</a:t>
            </a:fld>
            <a:endParaRPr lang="en-GB" sz="1200" b="0" i="0" u="none" strike="noStrike" kern="1200" cap="none" spc="0" baseline="0">
              <a:solidFill>
                <a:srgbClr val="000000"/>
              </a:solidFill>
              <a:uFillTx/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5866227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9F84D770-814D-4FC5-8881-6BF6C2622977}"/>
              </a:ext>
            </a:extLst>
          </p:cNvPr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2971800" cy="49901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defRPr>
            </a:lvl1pPr>
          </a:lstStyle>
          <a:p>
            <a:pPr lvl="0"/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C201057-F762-491F-95EC-871B02229000}"/>
              </a:ext>
            </a:extLst>
          </p:cNvPr>
          <p:cNvSpPr txBox="1">
            <a:spLocks noGrp="1"/>
          </p:cNvSpPr>
          <p:nvPr>
            <p:ph type="dt" idx="1"/>
          </p:nvPr>
        </p:nvSpPr>
        <p:spPr>
          <a:xfrm>
            <a:off x="3884608" y="0"/>
            <a:ext cx="2971800" cy="49901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defRPr>
            </a:lvl1pPr>
          </a:lstStyle>
          <a:p>
            <a:pPr lvl="0"/>
            <a:fld id="{B53AFD5F-2A39-45A8-9F4F-E3E7AF3828FE}" type="datetime1">
              <a:rPr lang="en-GB"/>
              <a:pPr lvl="0"/>
              <a:t>18/05/2018</a:t>
            </a:fld>
            <a:endParaRPr lang="en-GB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6BE511E2-5812-4A35-9D53-46F957ADFF1C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444498" y="1243017"/>
            <a:ext cx="5969002" cy="3357557"/>
          </a:xfrm>
          <a:prstGeom prst="rect">
            <a:avLst/>
          </a:prstGeom>
          <a:noFill/>
          <a:ln w="12701">
            <a:solidFill>
              <a:srgbClr val="000000"/>
            </a:solidFill>
            <a:prstDash val="solid"/>
          </a:ln>
        </p:spPr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8B62BD99-CE8C-43D8-8814-B13211C53893}"/>
              </a:ext>
            </a:extLst>
          </p:cNvPr>
          <p:cNvSpPr txBox="1">
            <a:spLocks noGrp="1"/>
          </p:cNvSpPr>
          <p:nvPr>
            <p:ph type="body" sz="quarter" idx="3"/>
          </p:nvPr>
        </p:nvSpPr>
        <p:spPr>
          <a:xfrm>
            <a:off x="685800" y="4786362"/>
            <a:ext cx="5486400" cy="391611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C236CD-1819-48E8-A1F3-7450D355F77A}"/>
              </a:ext>
            </a:extLst>
          </p:cNvPr>
          <p:cNvSpPr txBox="1">
            <a:spLocks noGrp="1"/>
          </p:cNvSpPr>
          <p:nvPr>
            <p:ph type="ftr" sz="quarter" idx="4"/>
          </p:nvPr>
        </p:nvSpPr>
        <p:spPr>
          <a:xfrm>
            <a:off x="0" y="9446675"/>
            <a:ext cx="2971800" cy="49901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b" anchorCtr="0" compatLnSpc="1">
            <a:noAutofit/>
          </a:bodyPr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defRPr>
            </a:lvl1pPr>
          </a:lstStyle>
          <a:p>
            <a:pPr lvl="0"/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7FBDB2-E65B-4250-B76D-750BAA69BC99}"/>
              </a:ext>
            </a:extLst>
          </p:cNvPr>
          <p:cNvSpPr txBox="1">
            <a:spLocks noGrp="1"/>
          </p:cNvSpPr>
          <p:nvPr>
            <p:ph type="sldNum" sz="quarter" idx="5"/>
          </p:nvPr>
        </p:nvSpPr>
        <p:spPr>
          <a:xfrm>
            <a:off x="3884608" y="9446675"/>
            <a:ext cx="2971800" cy="49901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b" anchorCtr="0" compatLnSpc="1">
            <a:noAutofit/>
          </a:bodyPr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defRPr>
            </a:lvl1pPr>
          </a:lstStyle>
          <a:p>
            <a:pPr lvl="0"/>
            <a:fld id="{EC323026-8DC8-4F8A-9242-7A812F9AD125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04329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marR="0" lvl="0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en-US" sz="1200" b="0" i="0" u="none" strike="noStrike" kern="1200" cap="none" spc="0" baseline="0">
        <a:solidFill>
          <a:srgbClr val="000000"/>
        </a:solidFill>
        <a:uFillTx/>
        <a:latin typeface="Calibri"/>
      </a:defRPr>
    </a:lvl1pPr>
    <a:lvl2pPr marL="457200" marR="0" lvl="1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en-US" sz="1200" b="0" i="0" u="none" strike="noStrike" kern="1200" cap="none" spc="0" baseline="0">
        <a:solidFill>
          <a:srgbClr val="000000"/>
        </a:solidFill>
        <a:uFillTx/>
        <a:latin typeface="Calibri"/>
      </a:defRPr>
    </a:lvl2pPr>
    <a:lvl3pPr marL="914400" marR="0" lvl="2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en-US" sz="1200" b="0" i="0" u="none" strike="noStrike" kern="1200" cap="none" spc="0" baseline="0">
        <a:solidFill>
          <a:srgbClr val="000000"/>
        </a:solidFill>
        <a:uFillTx/>
        <a:latin typeface="Calibri"/>
      </a:defRPr>
    </a:lvl3pPr>
    <a:lvl4pPr marL="1371600" marR="0" lvl="3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en-US" sz="1200" b="0" i="0" u="none" strike="noStrike" kern="1200" cap="none" spc="0" baseline="0">
        <a:solidFill>
          <a:srgbClr val="000000"/>
        </a:solidFill>
        <a:uFillTx/>
        <a:latin typeface="Calibri"/>
      </a:defRPr>
    </a:lvl4pPr>
    <a:lvl5pPr marL="1828800" marR="0" lvl="4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en-US" sz="1200" b="0" i="0" u="none" strike="noStrike" kern="1200" cap="none" spc="0" baseline="0">
        <a:solidFill>
          <a:srgbClr val="000000"/>
        </a:solidFill>
        <a:uFillTx/>
        <a:latin typeface="Calibri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4BCA0EEB-107D-4DFD-9A54-7F7B6A25A57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444500" y="1243013"/>
            <a:ext cx="5969000" cy="3357562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2B4E75EC-870E-47DC-9EC0-8E2BC0F2C800}"/>
              </a:ext>
            </a:extLst>
          </p:cNvPr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46A0F2B-E9B6-4E05-AD9C-D3EEBFA1F316}"/>
              </a:ext>
            </a:extLst>
          </p:cNvPr>
          <p:cNvSpPr txBox="1"/>
          <p:nvPr/>
        </p:nvSpPr>
        <p:spPr>
          <a:xfrm>
            <a:off x="3884608" y="9446675"/>
            <a:ext cx="2971800" cy="49901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b" anchorCtr="0" compatLnSpc="1">
            <a:noAutofit/>
          </a:bodyPr>
          <a:lstStyle/>
          <a:p>
            <a: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fld id="{A95F08BA-B435-4C99-A9F3-13027C1932DB}" type="slidenum">
              <a:t>1</a:t>
            </a:fld>
            <a:endParaRPr lang="en-GB" sz="1200" b="0" i="0" u="none" strike="noStrike" kern="1200" cap="none" spc="0" baseline="0">
              <a:solidFill>
                <a:srgbClr val="000000"/>
              </a:solidFill>
              <a:uFillTx/>
              <a:latin typeface="Calibri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A37F0F13-F85B-4EB8-B9A6-EE101951838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444500" y="1243013"/>
            <a:ext cx="5969000" cy="3357562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4261D859-FCDD-4E21-B400-C52EFBA19CBD}"/>
              </a:ext>
            </a:extLst>
          </p:cNvPr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AB8F3C7-5C99-4B27-ADC3-B847635AA7D2}"/>
              </a:ext>
            </a:extLst>
          </p:cNvPr>
          <p:cNvSpPr txBox="1"/>
          <p:nvPr/>
        </p:nvSpPr>
        <p:spPr>
          <a:xfrm>
            <a:off x="3884608" y="9446675"/>
            <a:ext cx="2971800" cy="49901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b" anchorCtr="0" compatLnSpc="1">
            <a:noAutofit/>
          </a:bodyPr>
          <a:lstStyle/>
          <a:p>
            <a: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fld id="{1F839773-1B20-4A51-BC93-BBAAF629C03E}" type="slidenum">
              <a:t>2</a:t>
            </a:fld>
            <a:endParaRPr lang="en-GB" sz="1200" b="0" i="0" u="none" strike="noStrike" kern="1200" cap="none" spc="0" baseline="0">
              <a:solidFill>
                <a:srgbClr val="000000"/>
              </a:solidFill>
              <a:uFillTx/>
              <a:latin typeface="Calibri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275CA631-0DD5-4109-9C9F-26AFFA17FB30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444500" y="1243013"/>
            <a:ext cx="5969000" cy="3357562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6FA60C3C-3059-48B6-BAC4-2725959C82DC}"/>
              </a:ext>
            </a:extLst>
          </p:cNvPr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3141D51-0B21-47F8-BBBA-AAC193C9264F}"/>
              </a:ext>
            </a:extLst>
          </p:cNvPr>
          <p:cNvSpPr txBox="1"/>
          <p:nvPr/>
        </p:nvSpPr>
        <p:spPr>
          <a:xfrm>
            <a:off x="3884608" y="9446675"/>
            <a:ext cx="2971800" cy="49901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b" anchorCtr="0" compatLnSpc="1">
            <a:noAutofit/>
          </a:bodyPr>
          <a:lstStyle/>
          <a:p>
            <a: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fld id="{43DE788F-AA06-440D-8FF4-228581151985}" type="slidenum">
              <a:t>3</a:t>
            </a:fld>
            <a:endParaRPr lang="en-GB" sz="1200" b="0" i="0" u="none" strike="noStrike" kern="1200" cap="none" spc="0" baseline="0">
              <a:solidFill>
                <a:srgbClr val="000000"/>
              </a:solidFill>
              <a:uFillTx/>
              <a:latin typeface="Calibri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935C4-87CC-4C82-91A0-512CF306882C}"/>
              </a:ext>
            </a:extLst>
          </p:cNvPr>
          <p:cNvSpPr txBox="1">
            <a:spLocks noGrp="1"/>
          </p:cNvSpPr>
          <p:nvPr>
            <p:ph type="ctrTitle"/>
          </p:nvPr>
        </p:nvSpPr>
        <p:spPr>
          <a:xfrm>
            <a:off x="1524003" y="1122361"/>
            <a:ext cx="9144000" cy="2387598"/>
          </a:xfrm>
        </p:spPr>
        <p:txBody>
          <a:bodyPr anchor="b" anchorCtr="1"/>
          <a:lstStyle>
            <a:lvl1pPr algn="ctr">
              <a:defRPr sz="6000"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520B4DB-DD8A-4888-8E94-14495C371BEB}"/>
              </a:ext>
            </a:extLst>
          </p:cNvPr>
          <p:cNvSpPr txBox="1">
            <a:spLocks noGrp="1"/>
          </p:cNvSpPr>
          <p:nvPr>
            <p:ph type="subTitle" idx="1"/>
          </p:nvPr>
        </p:nvSpPr>
        <p:spPr>
          <a:xfrm>
            <a:off x="1524003" y="3602041"/>
            <a:ext cx="9144000" cy="1655758"/>
          </a:xfrm>
        </p:spPr>
        <p:txBody>
          <a:bodyPr anchorCtr="1"/>
          <a:lstStyle>
            <a:lvl1pPr marL="0" indent="0" algn="ctr">
              <a:buNone/>
              <a:defRPr sz="2400"/>
            </a:lvl1pPr>
          </a:lstStyle>
          <a:p>
            <a:pPr lvl="0"/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1FC0A1-F635-4B01-8DBA-9C1934090359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9A39D811-63AA-423D-89FB-53DB7FF764C1}" type="datetime1">
              <a:rPr lang="en-GB"/>
              <a:pPr lvl="0"/>
              <a:t>18/05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6A2A22-C376-430A-8080-1508A5214B85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CC6420-EAE8-421D-AFF5-D98EB9D51298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0D40762-996B-4A21-AE00-1C02162DFB9B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4412350"/>
      </p:ext>
    </p:extLst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F2F7D2-17BE-4051-9885-F8F64D09A8F9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C46542-2A50-4380-A7D2-E9288390FA53}"/>
              </a:ext>
            </a:extLst>
          </p:cNvPr>
          <p:cNvSpPr txBox="1"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A42852-7B08-4DC1-A63E-751CCA8D9538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5062203B-3D25-47BA-9E61-D4E98D80C02E}" type="datetime1">
              <a:rPr lang="en-GB"/>
              <a:pPr lvl="0"/>
              <a:t>18/05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D56346-9F27-46FD-AF1F-EF1A977E201C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6B03CA-7CE6-46D2-AED8-997E3592EE62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98EAAC7-FDA1-4A39-9F89-1B798BD75499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2360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A43C51B-1795-4273-9BD7-899BD008B2C3}"/>
              </a:ext>
            </a:extLst>
          </p:cNvPr>
          <p:cNvSpPr txBox="1">
            <a:spLocks noGrp="1"/>
          </p:cNvSpPr>
          <p:nvPr>
            <p:ph type="title" orient="vert"/>
          </p:nvPr>
        </p:nvSpPr>
        <p:spPr>
          <a:xfrm>
            <a:off x="8724903" y="365129"/>
            <a:ext cx="2628899" cy="5811834"/>
          </a:xfrm>
        </p:spPr>
        <p:txBody>
          <a:bodyPr vert="eaVert"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E7D4882-3E49-4953-BB6B-A8F443885F4F}"/>
              </a:ext>
            </a:extLst>
          </p:cNvPr>
          <p:cNvSpPr txBox="1">
            <a:spLocks noGrp="1"/>
          </p:cNvSpPr>
          <p:nvPr>
            <p:ph type="body" orient="vert" idx="1"/>
          </p:nvPr>
        </p:nvSpPr>
        <p:spPr>
          <a:xfrm>
            <a:off x="838203" y="365129"/>
            <a:ext cx="7734296" cy="5811834"/>
          </a:xfrm>
        </p:spPr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2368D4-C67A-4701-B1CE-49409881337B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AF2C8A5-562E-4C25-8DC3-E43E7B27F122}" type="datetime1">
              <a:rPr lang="en-GB"/>
              <a:pPr lvl="0"/>
              <a:t>18/05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CC2CEE-C885-446B-BB8C-A84140317179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2CE0FE-58CF-44E0-A648-EC6061A0967B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D136FB50-EFC4-4D83-9BFA-1EE05CF6F4DF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9058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891064-E4F9-4A93-9483-897043BFF0B2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D8B02A-D835-4D67-8335-1B1AC2D26AF1}"/>
              </a:ext>
            </a:extLst>
          </p:cNvPr>
          <p:cNvSpPr txBox="1">
            <a:spLocks noGrp="1"/>
          </p:cNvSpPr>
          <p:nvPr>
            <p:ph idx="1"/>
          </p:nvPr>
        </p:nvSpPr>
        <p:spPr/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422022-D7C2-4835-913C-69F23B9C4754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16DA5CEE-3E91-449E-B2C1-FEE36C49D1FE}" type="datetime1">
              <a:rPr lang="en-GB"/>
              <a:pPr lvl="0"/>
              <a:t>18/05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DD4B11-67B8-4CF4-A6DA-38D19D7A830F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504D1B-13A5-4FD4-AA3A-CE4B950FCDEE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00241DB3-EAA9-4AA9-BA49-F58C1CA1C63C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3000937"/>
      </p:ext>
    </p:extLst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E8C3BC-ABA1-4580-9F02-9C74198F4FB3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1847" y="1709735"/>
            <a:ext cx="10515600" cy="2852735"/>
          </a:xfrm>
        </p:spPr>
        <p:txBody>
          <a:bodyPr anchor="b"/>
          <a:lstStyle>
            <a:lvl1pPr>
              <a:defRPr sz="6000"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A02BD9-1E78-47A1-B613-5B1D23FE8C18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831847" y="4589465"/>
            <a:ext cx="10515600" cy="1500182"/>
          </a:xfrm>
        </p:spPr>
        <p:txBody>
          <a:bodyPr/>
          <a:lstStyle>
            <a:lvl1pPr marL="0" indent="0">
              <a:buNone/>
              <a:defRPr sz="2400">
                <a:solidFill>
                  <a:srgbClr val="898989"/>
                </a:solidFill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F0A250-03A4-4C4C-BB48-7F6A65469C9A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D6E731CB-0037-4962-952C-60D1185A005D}" type="datetime1">
              <a:rPr lang="en-GB"/>
              <a:pPr lvl="0"/>
              <a:t>18/05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F785B-436D-409F-90DA-55A5C3A6188B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E8A57C-8BDB-4A5E-AD61-DE0958FA8323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6DF7CCA-8204-4B14-A2F9-E334623CAC06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87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60A49B-CBE6-4552-B048-E400E53D7F78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ED391A-E73A-47DA-B40C-41F95B156A33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838203" y="1825627"/>
            <a:ext cx="5181603" cy="4351336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91E4EF-8714-4917-8E7C-1B5FEC9BA117}"/>
              </a:ext>
            </a:extLst>
          </p:cNvPr>
          <p:cNvSpPr txBox="1">
            <a:spLocks noGrp="1"/>
          </p:cNvSpPr>
          <p:nvPr>
            <p:ph idx="2"/>
          </p:nvPr>
        </p:nvSpPr>
        <p:spPr>
          <a:xfrm>
            <a:off x="6172200" y="1825627"/>
            <a:ext cx="5181603" cy="4351336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45D628-E30D-4D98-B676-A5249A384BE8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D9429F8D-747B-4698-B71B-95795CF0FA18}" type="datetime1">
              <a:rPr lang="en-GB"/>
              <a:pPr lvl="0"/>
              <a:t>18/05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A1B086-0305-4AD1-83E6-C89FB5CF5886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7331FC-C6E9-4888-8011-D4DA0D4536DC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61DE22A0-52FE-498A-976D-B23FC91EB9F9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1248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DD360F-9207-4176-AEC9-B6A1C8DB66EA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9784" y="365129"/>
            <a:ext cx="10515600" cy="1325559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4F946D-9CC8-4E3E-8ABC-BB601458EEDA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839784" y="1681160"/>
            <a:ext cx="5157782" cy="823910"/>
          </a:xfrm>
        </p:spPr>
        <p:txBody>
          <a:bodyPr anchor="b"/>
          <a:lstStyle>
            <a:lvl1pPr marL="0" indent="0">
              <a:buNone/>
              <a:defRPr sz="2400" b="1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E9A448B-706A-46B1-8A16-BE3802DBD612}"/>
              </a:ext>
            </a:extLst>
          </p:cNvPr>
          <p:cNvSpPr txBox="1">
            <a:spLocks noGrp="1"/>
          </p:cNvSpPr>
          <p:nvPr>
            <p:ph idx="2"/>
          </p:nvPr>
        </p:nvSpPr>
        <p:spPr>
          <a:xfrm>
            <a:off x="839784" y="2505071"/>
            <a:ext cx="5157782" cy="3684583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4413D1D-D7D9-4544-925A-DB8850E3BE73}"/>
              </a:ext>
            </a:extLst>
          </p:cNvPr>
          <p:cNvSpPr txBox="1">
            <a:spLocks noGrp="1"/>
          </p:cNvSpPr>
          <p:nvPr>
            <p:ph type="body" idx="3"/>
          </p:nvPr>
        </p:nvSpPr>
        <p:spPr>
          <a:xfrm>
            <a:off x="6172200" y="1681160"/>
            <a:ext cx="5183184" cy="823910"/>
          </a:xfrm>
        </p:spPr>
        <p:txBody>
          <a:bodyPr anchor="b"/>
          <a:lstStyle>
            <a:lvl1pPr marL="0" indent="0">
              <a:buNone/>
              <a:defRPr sz="2400" b="1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A51F261-E704-4F86-BCE1-DDB778C0CAFC}"/>
              </a:ext>
            </a:extLst>
          </p:cNvPr>
          <p:cNvSpPr txBox="1">
            <a:spLocks noGrp="1"/>
          </p:cNvSpPr>
          <p:nvPr>
            <p:ph idx="4"/>
          </p:nvPr>
        </p:nvSpPr>
        <p:spPr>
          <a:xfrm>
            <a:off x="6172200" y="2505071"/>
            <a:ext cx="5183184" cy="3684583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D645FC0-4F88-4652-AF8F-4A3686A4067B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4D58EAEC-76D7-45B8-9422-153C9BED5681}" type="datetime1">
              <a:rPr lang="en-GB"/>
              <a:pPr lvl="0"/>
              <a:t>18/05/2018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2E3C1F3-C531-4C10-AA4A-A2D39E66B0EE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35775FD-EA01-41E9-B021-7FEC1DE38B55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452130CC-A213-4BD8-B8C0-4375C10F5BB6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3482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669987-1261-4D86-86BA-238AF59F1C2D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15CFFD0-AC7B-4F11-A0EE-FA02E87C8CA1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95912CDB-A093-4AA2-859A-74B3C13C9A11}" type="datetime1">
              <a:rPr lang="en-GB"/>
              <a:pPr lvl="0"/>
              <a:t>18/05/2018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9B7DB2A-C162-47A2-8F87-FE1E34B04828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27AD62-29A4-4209-9224-9A4FAB9724DD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AA1773EF-70E5-4213-9797-B3A84843DE10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9314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8A71D36-CB09-4909-BDE6-E00E3F905F7B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85B2A97-DCE1-4902-956D-D5304D649170}" type="datetime1">
              <a:rPr lang="en-GB"/>
              <a:pPr lvl="0"/>
              <a:t>18/05/2018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8FBDFA6-B350-4CE3-A647-819FFC96FFA6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2A682D3-F98C-4686-A381-2B314C8024D0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8D2A4F9E-1525-4297-8015-05A0F66E43B9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9623105"/>
      </p:ext>
    </p:extLst>
  </p:cSld>
  <p:clrMapOvr>
    <a:masterClrMapping/>
  </p:clrMapOvr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1F93D5-B586-4A77-BC70-F757A94B147E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9784" y="457200"/>
            <a:ext cx="3932240" cy="1600200"/>
          </a:xfrm>
        </p:spPr>
        <p:txBody>
          <a:bodyPr anchor="b"/>
          <a:lstStyle>
            <a:lvl1pPr>
              <a:defRPr sz="3200"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C4CBBB-428C-4A09-9260-A603AB95DD2A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5183184" y="987423"/>
            <a:ext cx="6172200" cy="487362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89824A-C480-4C10-943C-DF83DF328DF9}"/>
              </a:ext>
            </a:extLst>
          </p:cNvPr>
          <p:cNvSpPr txBox="1">
            <a:spLocks noGrp="1"/>
          </p:cNvSpPr>
          <p:nvPr>
            <p:ph type="body" idx="2"/>
          </p:nvPr>
        </p:nvSpPr>
        <p:spPr>
          <a:xfrm>
            <a:off x="839784" y="2057400"/>
            <a:ext cx="3932240" cy="3811584"/>
          </a:xfrm>
        </p:spPr>
        <p:txBody>
          <a:bodyPr/>
          <a:lstStyle>
            <a:lvl1pPr marL="0" indent="0">
              <a:buNone/>
              <a:defRPr sz="1600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67DB54-D027-4A94-9E57-9DF548590D2A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62DD3FE0-D210-42F2-A024-49394612B782}" type="datetime1">
              <a:rPr lang="en-GB"/>
              <a:pPr lvl="0"/>
              <a:t>18/05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FBF5C0-2E05-4DF4-B72B-E2FDD0470145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FC21CA-79BF-4F0F-834F-1B9F29E2B17B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0962A7D3-BF89-40FB-B4AF-CDA57F658F2B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86148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EA4BE0-9AEE-4DF0-9E9F-31D591B728F6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9784" y="457200"/>
            <a:ext cx="3932240" cy="1600200"/>
          </a:xfrm>
        </p:spPr>
        <p:txBody>
          <a:bodyPr anchor="b"/>
          <a:lstStyle>
            <a:lvl1pPr>
              <a:defRPr sz="3200"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BB602CB-C1F3-4280-A23A-DD2A3F4EE729}"/>
              </a:ext>
            </a:extLst>
          </p:cNvPr>
          <p:cNvSpPr txBox="1">
            <a:spLocks noGrp="1"/>
          </p:cNvSpPr>
          <p:nvPr>
            <p:ph type="pic" idx="1"/>
          </p:nvPr>
        </p:nvSpPr>
        <p:spPr>
          <a:xfrm>
            <a:off x="5183184" y="987423"/>
            <a:ext cx="6172200" cy="4873623"/>
          </a:xfrm>
        </p:spPr>
        <p:txBody>
          <a:bodyPr/>
          <a:lstStyle>
            <a:lvl1pPr marL="0" indent="0">
              <a:buNone/>
              <a:defRPr lang="en-GB" sz="3200"/>
            </a:lvl1pPr>
          </a:lstStyle>
          <a:p>
            <a:pPr lvl="0"/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A2A6C8-5124-4946-BE0B-2FAA30EC1C5C}"/>
              </a:ext>
            </a:extLst>
          </p:cNvPr>
          <p:cNvSpPr txBox="1">
            <a:spLocks noGrp="1"/>
          </p:cNvSpPr>
          <p:nvPr>
            <p:ph type="body" idx="2"/>
          </p:nvPr>
        </p:nvSpPr>
        <p:spPr>
          <a:xfrm>
            <a:off x="839784" y="2057400"/>
            <a:ext cx="3932240" cy="3811584"/>
          </a:xfrm>
        </p:spPr>
        <p:txBody>
          <a:bodyPr/>
          <a:lstStyle>
            <a:lvl1pPr marL="0" indent="0">
              <a:buNone/>
              <a:defRPr sz="1600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E23B3E-98E3-49D8-ABEF-E3E3FEE2A7B6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46F16180-E328-412D-9A93-EE78B504FB46}" type="datetime1">
              <a:rPr lang="en-GB"/>
              <a:pPr lvl="0"/>
              <a:t>18/05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0EEDB2-3A9A-40CC-A1A7-1155CC0FC7B3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990961-ACAC-42CF-8CBC-BAAC3C3D69A0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388C913F-714F-46E0-BC53-33299B23D9DE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6006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9EE9C05-36AA-4F7D-AFEB-90FAAC5B9AF8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8203" y="365129"/>
            <a:ext cx="10515600" cy="132555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rmAutofit/>
          </a:bodyPr>
          <a:lstStyle/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2E2BFA-E05F-41CB-BD6A-08BFD9F21480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838203" y="1825627"/>
            <a:ext cx="10515600" cy="4351336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7834CE-863C-4D18-ACDD-CCC5B510C75A}"/>
              </a:ext>
            </a:extLst>
          </p:cNvPr>
          <p:cNvSpPr txBox="1">
            <a:spLocks noGrp="1"/>
          </p:cNvSpPr>
          <p:nvPr>
            <p:ph type="dt" sz="half" idx="2"/>
          </p:nvPr>
        </p:nvSpPr>
        <p:spPr>
          <a:xfrm>
            <a:off x="838203" y="6356351"/>
            <a:ext cx="27432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Autofit/>
          </a:bodyPr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fld id="{620E544C-C5AA-4844-A28A-A5B4BD77584F}" type="datetime1">
              <a:rPr lang="en-GB"/>
              <a:pPr lvl="0"/>
              <a:t>18/05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C0A10E-0C7B-49FE-AE01-B11E81F224C0}"/>
              </a:ext>
            </a:extLst>
          </p:cNvPr>
          <p:cNvSpPr txBox="1">
            <a:spLocks noGrp="1"/>
          </p:cNvSpPr>
          <p:nvPr>
            <p:ph type="ftr" sz="quarter" idx="3"/>
          </p:nvPr>
        </p:nvSpPr>
        <p:spPr>
          <a:xfrm>
            <a:off x="4038603" y="6356351"/>
            <a:ext cx="41148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1" compatLnSpc="1">
            <a:noAutofit/>
          </a:bodyPr>
          <a:lstStyle>
            <a:lvl1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F03E09-DD2F-4036-82DB-0889B95CE8BD}"/>
              </a:ext>
            </a:extLst>
          </p:cNvPr>
          <p:cNvSpPr txBox="1">
            <a:spLocks noGrp="1"/>
          </p:cNvSpPr>
          <p:nvPr>
            <p:ph type="sldNum" sz="quarter" idx="4"/>
          </p:nvPr>
        </p:nvSpPr>
        <p:spPr>
          <a:xfrm>
            <a:off x="8610603" y="6356351"/>
            <a:ext cx="27432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Autofit/>
          </a:bodyPr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fld id="{99B23E5C-B0F8-4AC4-AD58-4CECA67B7FF5}" type="slidenum"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marL="0" marR="0" lvl="0" indent="0" algn="l" defTabSz="914400" rtl="0" fontAlgn="auto" hangingPunct="1">
        <a:lnSpc>
          <a:spcPct val="90000"/>
        </a:lnSpc>
        <a:spcBef>
          <a:spcPts val="0"/>
        </a:spcBef>
        <a:spcAft>
          <a:spcPts val="0"/>
        </a:spcAft>
        <a:buNone/>
        <a:tabLst/>
        <a:defRPr lang="en-US" sz="4400" b="0" i="0" u="none" strike="noStrike" kern="1200" cap="none" spc="0" baseline="0">
          <a:solidFill>
            <a:srgbClr val="000000"/>
          </a:solidFill>
          <a:uFillTx/>
          <a:latin typeface="Calibri Light"/>
        </a:defRPr>
      </a:lvl1pPr>
    </p:titleStyle>
    <p:bodyStyle>
      <a:lvl1pPr marL="228600" marR="0" lvl="0" indent="-228600" algn="l" defTabSz="914400" rtl="0" fontAlgn="auto" hangingPunct="1">
        <a:lnSpc>
          <a:spcPct val="90000"/>
        </a:lnSpc>
        <a:spcBef>
          <a:spcPts val="1000"/>
        </a:spcBef>
        <a:spcAft>
          <a:spcPts val="0"/>
        </a:spcAft>
        <a:buSzPct val="100000"/>
        <a:buFont typeface="Arial" pitchFamily="34"/>
        <a:buChar char="•"/>
        <a:tabLst/>
        <a:defRPr lang="en-US" sz="2800" b="0" i="0" u="none" strike="noStrike" kern="1200" cap="none" spc="0" baseline="0">
          <a:solidFill>
            <a:srgbClr val="000000"/>
          </a:solidFill>
          <a:uFillTx/>
          <a:latin typeface="Calibri"/>
        </a:defRPr>
      </a:lvl1pPr>
      <a:lvl2pPr marL="685800" marR="0" lvl="1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n-US" sz="2400" b="0" i="0" u="none" strike="noStrike" kern="1200" cap="none" spc="0" baseline="0">
          <a:solidFill>
            <a:srgbClr val="000000"/>
          </a:solidFill>
          <a:uFillTx/>
          <a:latin typeface="Calibri"/>
        </a:defRPr>
      </a:lvl2pPr>
      <a:lvl3pPr marL="1143000" marR="0" lvl="2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n-US" sz="2000" b="0" i="0" u="none" strike="noStrike" kern="1200" cap="none" spc="0" baseline="0">
          <a:solidFill>
            <a:srgbClr val="000000"/>
          </a:solidFill>
          <a:uFillTx/>
          <a:latin typeface="Calibri"/>
        </a:defRPr>
      </a:lvl3pPr>
      <a:lvl4pPr marL="1600200" marR="0" lvl="3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n-US" sz="1800" b="0" i="0" u="none" strike="noStrike" kern="1200" cap="none" spc="0" baseline="0">
          <a:solidFill>
            <a:srgbClr val="000000"/>
          </a:solidFill>
          <a:uFillTx/>
          <a:latin typeface="Calibri"/>
        </a:defRPr>
      </a:lvl4pPr>
      <a:lvl5pPr marL="2057400" marR="0" lvl="4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n-US" sz="1800" b="0" i="0" u="none" strike="noStrike" kern="1200" cap="none" spc="0" baseline="0">
          <a:solidFill>
            <a:srgbClr val="000000"/>
          </a:solidFill>
          <a:uFillTx/>
          <a:latin typeface="Calibri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808C2-D177-42FE-A670-EE7867E41053}"/>
              </a:ext>
            </a:extLst>
          </p:cNvPr>
          <p:cNvSpPr txBox="1">
            <a:spLocks noGrp="1"/>
          </p:cNvSpPr>
          <p:nvPr>
            <p:ph type="ctrTitle"/>
          </p:nvPr>
        </p:nvSpPr>
        <p:spPr/>
        <p:txBody>
          <a:bodyPr/>
          <a:lstStyle/>
          <a:p>
            <a:pPr lvl="0"/>
            <a:r>
              <a:rPr lang="en-GB" sz="2000" b="1">
                <a:latin typeface="Times New Roman" pitchFamily="18"/>
                <a:cs typeface="Times New Roman" pitchFamily="18"/>
              </a:rPr>
              <a:t>Reference 089 serotype aligned to ‘O89m’ in </a:t>
            </a:r>
            <a:r>
              <a:rPr lang="en-GB" sz="2000" b="1" i="1">
                <a:latin typeface="Times New Roman" pitchFamily="18"/>
                <a:cs typeface="Times New Roman" pitchFamily="18"/>
              </a:rPr>
              <a:t>E.coli </a:t>
            </a:r>
            <a:r>
              <a:rPr lang="en-GB" sz="2000" b="1">
                <a:latin typeface="Times New Roman" pitchFamily="18"/>
                <a:cs typeface="Times New Roman" pitchFamily="18"/>
              </a:rPr>
              <a:t>26561 and genomic location of ‘O89m’ in relation to </a:t>
            </a:r>
            <a:r>
              <a:rPr lang="en-GB" sz="2000" b="1" i="1">
                <a:latin typeface="Times New Roman" pitchFamily="18"/>
                <a:cs typeface="Times New Roman" pitchFamily="18"/>
              </a:rPr>
              <a:t>E.coli</a:t>
            </a:r>
            <a:r>
              <a:rPr lang="en-GB" sz="2000" b="1">
                <a:latin typeface="Times New Roman" pitchFamily="18"/>
                <a:cs typeface="Times New Roman" pitchFamily="18"/>
              </a:rPr>
              <a:t>-K12 MG1655.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731582-FFB5-4C86-BE05-03D464929729}"/>
              </a:ext>
            </a:extLst>
          </p:cNvPr>
          <p:cNvSpPr txBox="1">
            <a:spLocks noGrp="1"/>
          </p:cNvSpPr>
          <p:nvPr>
            <p:ph type="subTitle" idx="1"/>
          </p:nvPr>
        </p:nvSpPr>
        <p:spPr/>
        <p:txBody>
          <a:bodyPr/>
          <a:lstStyle/>
          <a:p>
            <a:pPr lvl="0"/>
            <a:endParaRPr lang="en-GB"/>
          </a:p>
          <a:p>
            <a:pPr lvl="0"/>
            <a:endParaRPr lang="en-GB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6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91CDBA-CEB1-46EF-A070-33FCAF082503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489524" y="415027"/>
            <a:ext cx="10855034" cy="434714"/>
          </a:xfrm>
        </p:spPr>
        <p:txBody>
          <a:bodyPr/>
          <a:lstStyle/>
          <a:p>
            <a:pPr lvl="0"/>
            <a:r>
              <a:rPr lang="en-GB" sz="1200" b="1">
                <a:latin typeface="Times New Roman" pitchFamily="18"/>
                <a:cs typeface="Times New Roman" pitchFamily="18"/>
              </a:rPr>
              <a:t>E.coli NCTC9089 vs. 26561 vs. E.coli K12</a:t>
            </a:r>
          </a:p>
        </p:txBody>
      </p:sp>
      <p:pic>
        <p:nvPicPr>
          <p:cNvPr id="3" name="Content Placeholder 3">
            <a:extLst>
              <a:ext uri="{FF2B5EF4-FFF2-40B4-BE49-F238E27FC236}">
                <a16:creationId xmlns:a16="http://schemas.microsoft.com/office/drawing/2014/main" id="{59D8DA22-8500-4F27-AA92-C9BC50E48DC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rcRect b="27082"/>
          <a:stretch>
            <a:fillRect/>
          </a:stretch>
        </p:blipFill>
        <p:spPr>
          <a:xfrm>
            <a:off x="567705" y="1106661"/>
            <a:ext cx="10515600" cy="2706578"/>
          </a:xfrm>
        </p:spPr>
      </p:pic>
      <p:grpSp>
        <p:nvGrpSpPr>
          <p:cNvPr id="4" name="Group 42">
            <a:extLst>
              <a:ext uri="{FF2B5EF4-FFF2-40B4-BE49-F238E27FC236}">
                <a16:creationId xmlns:a16="http://schemas.microsoft.com/office/drawing/2014/main" id="{1BF0CCBE-40AC-48ED-9A66-977C2A0957F6}"/>
              </a:ext>
            </a:extLst>
          </p:cNvPr>
          <p:cNvGrpSpPr/>
          <p:nvPr/>
        </p:nvGrpSpPr>
        <p:grpSpPr>
          <a:xfrm>
            <a:off x="695035" y="2132691"/>
            <a:ext cx="1840668" cy="746708"/>
            <a:chOff x="695035" y="2132691"/>
            <a:chExt cx="1840668" cy="746708"/>
          </a:xfrm>
        </p:grpSpPr>
        <p:grpSp>
          <p:nvGrpSpPr>
            <p:cNvPr id="5" name="Group 10">
              <a:extLst>
                <a:ext uri="{FF2B5EF4-FFF2-40B4-BE49-F238E27FC236}">
                  <a16:creationId xmlns:a16="http://schemas.microsoft.com/office/drawing/2014/main" id="{1BEF316B-9D4A-4A7D-8B1D-68134E3F42D5}"/>
                </a:ext>
              </a:extLst>
            </p:cNvPr>
            <p:cNvGrpSpPr/>
            <p:nvPr/>
          </p:nvGrpSpPr>
          <p:grpSpPr>
            <a:xfrm>
              <a:off x="695035" y="2241816"/>
              <a:ext cx="267855" cy="607883"/>
              <a:chOff x="695035" y="2241816"/>
              <a:chExt cx="267855" cy="607883"/>
            </a:xfrm>
          </p:grpSpPr>
          <p:grpSp>
            <p:nvGrpSpPr>
              <p:cNvPr id="6" name="Group 9">
                <a:extLst>
                  <a:ext uri="{FF2B5EF4-FFF2-40B4-BE49-F238E27FC236}">
                    <a16:creationId xmlns:a16="http://schemas.microsoft.com/office/drawing/2014/main" id="{A784B2C5-33E5-42F6-906E-FBFA0E2CE709}"/>
                  </a:ext>
                </a:extLst>
              </p:cNvPr>
              <p:cNvGrpSpPr/>
              <p:nvPr/>
            </p:nvGrpSpPr>
            <p:grpSpPr>
              <a:xfrm>
                <a:off x="695035" y="2241816"/>
                <a:ext cx="267855" cy="387713"/>
                <a:chOff x="695035" y="2241816"/>
                <a:chExt cx="267855" cy="387713"/>
              </a:xfrm>
            </p:grpSpPr>
            <p:sp>
              <p:nvSpPr>
                <p:cNvPr id="7" name="Arrow: Right 4">
                  <a:extLst>
                    <a:ext uri="{FF2B5EF4-FFF2-40B4-BE49-F238E27FC236}">
                      <a16:creationId xmlns:a16="http://schemas.microsoft.com/office/drawing/2014/main" id="{3F82F448-96AF-4A7F-B457-1F8C6C31C959}"/>
                    </a:ext>
                  </a:extLst>
                </p:cNvPr>
                <p:cNvSpPr/>
                <p:nvPr/>
              </p:nvSpPr>
              <p:spPr>
                <a:xfrm>
                  <a:off x="695035" y="2241816"/>
                  <a:ext cx="267855" cy="171257"/>
                </a:xfrm>
                <a:custGeom>
                  <a:avLst>
                    <a:gd name="f0" fmla="val 14695"/>
                    <a:gd name="f1" fmla="val 5400"/>
                  </a:avLst>
                  <a:gdLst>
                    <a:gd name="f2" fmla="val 10800000"/>
                    <a:gd name="f3" fmla="val 5400000"/>
                    <a:gd name="f4" fmla="val 180"/>
                    <a:gd name="f5" fmla="val w"/>
                    <a:gd name="f6" fmla="val h"/>
                    <a:gd name="f7" fmla="val 0"/>
                    <a:gd name="f8" fmla="val 21600"/>
                    <a:gd name="f9" fmla="val 10800"/>
                    <a:gd name="f10" fmla="+- 0 0 0"/>
                    <a:gd name="f11" fmla="+- 0 0 180"/>
                    <a:gd name="f12" fmla="*/ f5 1 21600"/>
                    <a:gd name="f13" fmla="*/ f6 1 21600"/>
                    <a:gd name="f14" fmla="+- f8 0 f7"/>
                    <a:gd name="f15" fmla="pin 0 f0 21600"/>
                    <a:gd name="f16" fmla="pin 0 f1 10800"/>
                    <a:gd name="f17" fmla="*/ f10 f2 1"/>
                    <a:gd name="f18" fmla="*/ f11 f2 1"/>
                    <a:gd name="f19" fmla="val f15"/>
                    <a:gd name="f20" fmla="val f16"/>
                    <a:gd name="f21" fmla="*/ f14 1 21600"/>
                    <a:gd name="f22" fmla="*/ f15 f12 1"/>
                    <a:gd name="f23" fmla="*/ f16 f13 1"/>
                    <a:gd name="f24" fmla="*/ f17 1 f4"/>
                    <a:gd name="f25" fmla="*/ f18 1 f4"/>
                    <a:gd name="f26" fmla="+- 21600 0 f20"/>
                    <a:gd name="f27" fmla="+- 21600 0 f19"/>
                    <a:gd name="f28" fmla="*/ 0 f21 1"/>
                    <a:gd name="f29" fmla="*/ 21600 f21 1"/>
                    <a:gd name="f30" fmla="*/ f20 f13 1"/>
                    <a:gd name="f31" fmla="*/ f19 f12 1"/>
                    <a:gd name="f32" fmla="+- f24 0 f3"/>
                    <a:gd name="f33" fmla="+- f25 0 f3"/>
                    <a:gd name="f34" fmla="*/ f27 f20 1"/>
                    <a:gd name="f35" fmla="*/ f28 1 f21"/>
                    <a:gd name="f36" fmla="*/ f29 1 f21"/>
                    <a:gd name="f37" fmla="*/ f26 f13 1"/>
                    <a:gd name="f38" fmla="*/ f34 1 10800"/>
                    <a:gd name="f39" fmla="*/ f35 f12 1"/>
                    <a:gd name="f40" fmla="*/ f35 f13 1"/>
                    <a:gd name="f41" fmla="*/ f36 f13 1"/>
                    <a:gd name="f42" fmla="+- f19 f38 0"/>
                    <a:gd name="f43" fmla="*/ f42 f12 1"/>
                  </a:gdLst>
                  <a:ahLst>
                    <a:ahXY gdRefX="f0" minX="f7" maxX="f8" gdRefY="f1" minY="f7" maxY="f9">
                      <a:pos x="f22" y="f23"/>
                    </a:ahXY>
                  </a:ahLst>
                  <a:cxnLst>
                    <a:cxn ang="3cd4">
                      <a:pos x="hc" y="t"/>
                    </a:cxn>
                    <a:cxn ang="0">
                      <a:pos x="r" y="vc"/>
                    </a:cxn>
                    <a:cxn ang="cd4">
                      <a:pos x="hc" y="b"/>
                    </a:cxn>
                    <a:cxn ang="cd2">
                      <a:pos x="l" y="vc"/>
                    </a:cxn>
                    <a:cxn ang="f32">
                      <a:pos x="f31" y="f40"/>
                    </a:cxn>
                    <a:cxn ang="f33">
                      <a:pos x="f31" y="f41"/>
                    </a:cxn>
                  </a:cxnLst>
                  <a:rect l="f39" t="f30" r="f43" b="f37"/>
                  <a:pathLst>
                    <a:path w="21600" h="21600">
                      <a:moveTo>
                        <a:pt x="f7" y="f20"/>
                      </a:moveTo>
                      <a:lnTo>
                        <a:pt x="f19" y="f20"/>
                      </a:lnTo>
                      <a:lnTo>
                        <a:pt x="f19" y="f7"/>
                      </a:lnTo>
                      <a:lnTo>
                        <a:pt x="f8" y="f9"/>
                      </a:lnTo>
                      <a:lnTo>
                        <a:pt x="f19" y="f8"/>
                      </a:lnTo>
                      <a:lnTo>
                        <a:pt x="f19" y="f26"/>
                      </a:lnTo>
                      <a:lnTo>
                        <a:pt x="f7" y="f26"/>
                      </a:lnTo>
                      <a:close/>
                    </a:path>
                  </a:pathLst>
                </a:custGeom>
                <a:solidFill>
                  <a:srgbClr val="F33DC3"/>
                </a:solidFill>
                <a:ln w="12701" cap="flat">
                  <a:solidFill>
                    <a:srgbClr val="41719C"/>
                  </a:solidFill>
                  <a:prstDash val="solid"/>
                  <a:miter/>
                </a:ln>
              </p:spPr>
              <p:txBody>
                <a:bodyPr vert="horz" wrap="square" lIns="91440" tIns="45720" rIns="91440" bIns="45720" anchor="ctr" anchorCtr="1" compatLnSpc="1">
                  <a:noAutofit/>
                </a:bodyPr>
                <a:lstStyle/>
                <a:p>
                  <a:pPr marL="0" marR="0" lvl="0" indent="0" algn="ctr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endParaRPr lang="en-GB" sz="1800" b="0" i="0" u="none" strike="noStrike" kern="1200" cap="none" spc="0" baseline="0">
                    <a:solidFill>
                      <a:srgbClr val="FFFFFF"/>
                    </a:solidFill>
                    <a:uFillTx/>
                    <a:latin typeface="Calibri"/>
                  </a:endParaRPr>
                </a:p>
              </p:txBody>
            </p:sp>
            <p:sp>
              <p:nvSpPr>
                <p:cNvPr id="8" name="Arrow: Right 7">
                  <a:extLst>
                    <a:ext uri="{FF2B5EF4-FFF2-40B4-BE49-F238E27FC236}">
                      <a16:creationId xmlns:a16="http://schemas.microsoft.com/office/drawing/2014/main" id="{08BE1352-47AB-46A0-9F1C-6CE8D6FE08E9}"/>
                    </a:ext>
                  </a:extLst>
                </p:cNvPr>
                <p:cNvSpPr/>
                <p:nvPr/>
              </p:nvSpPr>
              <p:spPr>
                <a:xfrm>
                  <a:off x="695035" y="2458272"/>
                  <a:ext cx="267855" cy="171257"/>
                </a:xfrm>
                <a:custGeom>
                  <a:avLst>
                    <a:gd name="f0" fmla="val 14695"/>
                    <a:gd name="f1" fmla="val 5400"/>
                  </a:avLst>
                  <a:gdLst>
                    <a:gd name="f2" fmla="val 10800000"/>
                    <a:gd name="f3" fmla="val 5400000"/>
                    <a:gd name="f4" fmla="val 180"/>
                    <a:gd name="f5" fmla="val w"/>
                    <a:gd name="f6" fmla="val h"/>
                    <a:gd name="f7" fmla="val 0"/>
                    <a:gd name="f8" fmla="val 21600"/>
                    <a:gd name="f9" fmla="val 10800"/>
                    <a:gd name="f10" fmla="+- 0 0 0"/>
                    <a:gd name="f11" fmla="+- 0 0 180"/>
                    <a:gd name="f12" fmla="*/ f5 1 21600"/>
                    <a:gd name="f13" fmla="*/ f6 1 21600"/>
                    <a:gd name="f14" fmla="+- f8 0 f7"/>
                    <a:gd name="f15" fmla="pin 0 f0 21600"/>
                    <a:gd name="f16" fmla="pin 0 f1 10800"/>
                    <a:gd name="f17" fmla="*/ f10 f2 1"/>
                    <a:gd name="f18" fmla="*/ f11 f2 1"/>
                    <a:gd name="f19" fmla="val f15"/>
                    <a:gd name="f20" fmla="val f16"/>
                    <a:gd name="f21" fmla="*/ f14 1 21600"/>
                    <a:gd name="f22" fmla="*/ f15 f12 1"/>
                    <a:gd name="f23" fmla="*/ f16 f13 1"/>
                    <a:gd name="f24" fmla="*/ f17 1 f4"/>
                    <a:gd name="f25" fmla="*/ f18 1 f4"/>
                    <a:gd name="f26" fmla="+- 21600 0 f20"/>
                    <a:gd name="f27" fmla="+- 21600 0 f19"/>
                    <a:gd name="f28" fmla="*/ 0 f21 1"/>
                    <a:gd name="f29" fmla="*/ 21600 f21 1"/>
                    <a:gd name="f30" fmla="*/ f20 f13 1"/>
                    <a:gd name="f31" fmla="*/ f19 f12 1"/>
                    <a:gd name="f32" fmla="+- f24 0 f3"/>
                    <a:gd name="f33" fmla="+- f25 0 f3"/>
                    <a:gd name="f34" fmla="*/ f27 f20 1"/>
                    <a:gd name="f35" fmla="*/ f28 1 f21"/>
                    <a:gd name="f36" fmla="*/ f29 1 f21"/>
                    <a:gd name="f37" fmla="*/ f26 f13 1"/>
                    <a:gd name="f38" fmla="*/ f34 1 10800"/>
                    <a:gd name="f39" fmla="*/ f35 f12 1"/>
                    <a:gd name="f40" fmla="*/ f35 f13 1"/>
                    <a:gd name="f41" fmla="*/ f36 f13 1"/>
                    <a:gd name="f42" fmla="+- f19 f38 0"/>
                    <a:gd name="f43" fmla="*/ f42 f12 1"/>
                  </a:gdLst>
                  <a:ahLst>
                    <a:ahXY gdRefX="f0" minX="f7" maxX="f8" gdRefY="f1" minY="f7" maxY="f9">
                      <a:pos x="f22" y="f23"/>
                    </a:ahXY>
                  </a:ahLst>
                  <a:cxnLst>
                    <a:cxn ang="3cd4">
                      <a:pos x="hc" y="t"/>
                    </a:cxn>
                    <a:cxn ang="0">
                      <a:pos x="r" y="vc"/>
                    </a:cxn>
                    <a:cxn ang="cd4">
                      <a:pos x="hc" y="b"/>
                    </a:cxn>
                    <a:cxn ang="cd2">
                      <a:pos x="l" y="vc"/>
                    </a:cxn>
                    <a:cxn ang="f32">
                      <a:pos x="f31" y="f40"/>
                    </a:cxn>
                    <a:cxn ang="f33">
                      <a:pos x="f31" y="f41"/>
                    </a:cxn>
                  </a:cxnLst>
                  <a:rect l="f39" t="f30" r="f43" b="f37"/>
                  <a:pathLst>
                    <a:path w="21600" h="21600">
                      <a:moveTo>
                        <a:pt x="f7" y="f20"/>
                      </a:moveTo>
                      <a:lnTo>
                        <a:pt x="f19" y="f20"/>
                      </a:lnTo>
                      <a:lnTo>
                        <a:pt x="f19" y="f7"/>
                      </a:lnTo>
                      <a:lnTo>
                        <a:pt x="f8" y="f9"/>
                      </a:lnTo>
                      <a:lnTo>
                        <a:pt x="f19" y="f8"/>
                      </a:lnTo>
                      <a:lnTo>
                        <a:pt x="f19" y="f26"/>
                      </a:lnTo>
                      <a:lnTo>
                        <a:pt x="f7" y="f26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 w="12701" cap="flat">
                  <a:solidFill>
                    <a:srgbClr val="41719C"/>
                  </a:solidFill>
                  <a:prstDash val="solid"/>
                  <a:miter/>
                </a:ln>
              </p:spPr>
              <p:txBody>
                <a:bodyPr vert="horz" wrap="square" lIns="91440" tIns="45720" rIns="91440" bIns="45720" anchor="ctr" anchorCtr="1" compatLnSpc="1">
                  <a:noAutofit/>
                </a:bodyPr>
                <a:lstStyle/>
                <a:p>
                  <a:pPr marL="0" marR="0" lvl="0" indent="0" algn="ctr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endParaRPr lang="en-GB" sz="1800" b="0" i="0" u="none" strike="noStrike" kern="1200" cap="none" spc="0" baseline="0">
                    <a:solidFill>
                      <a:srgbClr val="FFFFFF"/>
                    </a:solidFill>
                    <a:uFillTx/>
                    <a:latin typeface="Calibri"/>
                  </a:endParaRPr>
                </a:p>
              </p:txBody>
            </p:sp>
          </p:grpSp>
          <p:sp>
            <p:nvSpPr>
              <p:cNvPr id="9" name="Arrow: Right 8">
                <a:extLst>
                  <a:ext uri="{FF2B5EF4-FFF2-40B4-BE49-F238E27FC236}">
                    <a16:creationId xmlns:a16="http://schemas.microsoft.com/office/drawing/2014/main" id="{B037EF3A-605F-46A6-8669-277664F40848}"/>
                  </a:ext>
                </a:extLst>
              </p:cNvPr>
              <p:cNvSpPr/>
              <p:nvPr/>
            </p:nvSpPr>
            <p:spPr>
              <a:xfrm>
                <a:off x="695035" y="2678442"/>
                <a:ext cx="267855" cy="171257"/>
              </a:xfrm>
              <a:custGeom>
                <a:avLst>
                  <a:gd name="f0" fmla="val 14695"/>
                  <a:gd name="f1" fmla="val 5400"/>
                </a:avLst>
                <a:gdLst>
                  <a:gd name="f2" fmla="val 10800000"/>
                  <a:gd name="f3" fmla="val 5400000"/>
                  <a:gd name="f4" fmla="val 180"/>
                  <a:gd name="f5" fmla="val w"/>
                  <a:gd name="f6" fmla="val h"/>
                  <a:gd name="f7" fmla="val 0"/>
                  <a:gd name="f8" fmla="val 21600"/>
                  <a:gd name="f9" fmla="val 10800"/>
                  <a:gd name="f10" fmla="+- 0 0 0"/>
                  <a:gd name="f11" fmla="+- 0 0 180"/>
                  <a:gd name="f12" fmla="*/ f5 1 21600"/>
                  <a:gd name="f13" fmla="*/ f6 1 21600"/>
                  <a:gd name="f14" fmla="+- f8 0 f7"/>
                  <a:gd name="f15" fmla="pin 0 f0 21600"/>
                  <a:gd name="f16" fmla="pin 0 f1 10800"/>
                  <a:gd name="f17" fmla="*/ f10 f2 1"/>
                  <a:gd name="f18" fmla="*/ f11 f2 1"/>
                  <a:gd name="f19" fmla="val f15"/>
                  <a:gd name="f20" fmla="val f16"/>
                  <a:gd name="f21" fmla="*/ f14 1 21600"/>
                  <a:gd name="f22" fmla="*/ f15 f12 1"/>
                  <a:gd name="f23" fmla="*/ f16 f13 1"/>
                  <a:gd name="f24" fmla="*/ f17 1 f4"/>
                  <a:gd name="f25" fmla="*/ f18 1 f4"/>
                  <a:gd name="f26" fmla="+- 21600 0 f20"/>
                  <a:gd name="f27" fmla="+- 21600 0 f19"/>
                  <a:gd name="f28" fmla="*/ 0 f21 1"/>
                  <a:gd name="f29" fmla="*/ 21600 f21 1"/>
                  <a:gd name="f30" fmla="*/ f20 f13 1"/>
                  <a:gd name="f31" fmla="*/ f19 f12 1"/>
                  <a:gd name="f32" fmla="+- f24 0 f3"/>
                  <a:gd name="f33" fmla="+- f25 0 f3"/>
                  <a:gd name="f34" fmla="*/ f27 f20 1"/>
                  <a:gd name="f35" fmla="*/ f28 1 f21"/>
                  <a:gd name="f36" fmla="*/ f29 1 f21"/>
                  <a:gd name="f37" fmla="*/ f26 f13 1"/>
                  <a:gd name="f38" fmla="*/ f34 1 10800"/>
                  <a:gd name="f39" fmla="*/ f35 f12 1"/>
                  <a:gd name="f40" fmla="*/ f35 f13 1"/>
                  <a:gd name="f41" fmla="*/ f36 f13 1"/>
                  <a:gd name="f42" fmla="+- f19 f38 0"/>
                  <a:gd name="f43" fmla="*/ f42 f12 1"/>
                </a:gdLst>
                <a:ahLst>
                  <a:ahXY gdRefX="f0" minX="f7" maxX="f8" gdRefY="f1" minY="f7" maxY="f9">
                    <a:pos x="f22" y="f23"/>
                  </a:ahXY>
                </a:ahLst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32">
                    <a:pos x="f31" y="f40"/>
                  </a:cxn>
                  <a:cxn ang="f33">
                    <a:pos x="f31" y="f41"/>
                  </a:cxn>
                </a:cxnLst>
                <a:rect l="f39" t="f30" r="f43" b="f37"/>
                <a:pathLst>
                  <a:path w="21600" h="21600">
                    <a:moveTo>
                      <a:pt x="f7" y="f20"/>
                    </a:moveTo>
                    <a:lnTo>
                      <a:pt x="f19" y="f20"/>
                    </a:lnTo>
                    <a:lnTo>
                      <a:pt x="f19" y="f7"/>
                    </a:lnTo>
                    <a:lnTo>
                      <a:pt x="f8" y="f9"/>
                    </a:lnTo>
                    <a:lnTo>
                      <a:pt x="f19" y="f8"/>
                    </a:lnTo>
                    <a:lnTo>
                      <a:pt x="f19" y="f26"/>
                    </a:lnTo>
                    <a:lnTo>
                      <a:pt x="f7" y="f26"/>
                    </a:lnTo>
                    <a:close/>
                  </a:path>
                </a:pathLst>
              </a:custGeom>
              <a:solidFill>
                <a:srgbClr val="FF0000"/>
              </a:solidFill>
              <a:ln w="12701" cap="flat">
                <a:solidFill>
                  <a:srgbClr val="41719C"/>
                </a:solidFill>
                <a:prstDash val="solid"/>
                <a:miter/>
              </a:ln>
            </p:spPr>
            <p:txBody>
              <a:bodyPr vert="horz" wrap="square" lIns="91440" tIns="45720" rIns="91440" bIns="45720" anchor="ctr" anchorCtr="1" compatLnSpc="1">
                <a:noAutofit/>
              </a:bodyPr>
              <a:lstStyle/>
              <a:p>
                <a:pPr marL="0" marR="0" lvl="0" indent="0" algn="ctr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en-GB" sz="1800" b="0" i="0" u="none" strike="noStrike" kern="1200" cap="none" spc="0" baseline="0">
                  <a:solidFill>
                    <a:srgbClr val="FFFFFF"/>
                  </a:solidFill>
                  <a:uFillTx/>
                  <a:latin typeface="Calibri"/>
                </a:endParaRPr>
              </a:p>
            </p:txBody>
          </p:sp>
        </p:grpSp>
        <p:sp>
          <p:nvSpPr>
            <p:cNvPr id="10" name="TextBox 11">
              <a:extLst>
                <a:ext uri="{FF2B5EF4-FFF2-40B4-BE49-F238E27FC236}">
                  <a16:creationId xmlns:a16="http://schemas.microsoft.com/office/drawing/2014/main" id="{FE59A9AA-8046-4AAE-9F83-F2536EFD04CB}"/>
                </a:ext>
              </a:extLst>
            </p:cNvPr>
            <p:cNvSpPr txBox="1"/>
            <p:nvPr/>
          </p:nvSpPr>
          <p:spPr>
            <a:xfrm>
              <a:off x="956288" y="2132691"/>
              <a:ext cx="1579415" cy="746708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900" b="0" i="0" u="none" strike="noStrike" kern="1200" cap="none" spc="0" baseline="0">
                  <a:solidFill>
                    <a:srgbClr val="000000"/>
                  </a:solidFill>
                  <a:uFillTx/>
                  <a:latin typeface="Calibri"/>
                </a:rPr>
                <a:t>Capsule genes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en-GB" sz="9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900" b="0" i="0" u="none" strike="noStrike" kern="1200" cap="none" spc="0" baseline="0">
                  <a:solidFill>
                    <a:srgbClr val="000000"/>
                  </a:solidFill>
                  <a:uFillTx/>
                  <a:latin typeface="Calibri"/>
                </a:rPr>
                <a:t>O-antigen genes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en-GB" sz="9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900" b="0" i="0" u="none" strike="noStrike" kern="1200" cap="none" spc="0" baseline="0">
                  <a:solidFill>
                    <a:srgbClr val="000000"/>
                  </a:solidFill>
                  <a:uFillTx/>
                  <a:latin typeface="Calibri"/>
                </a:rPr>
                <a:t>his genes</a:t>
              </a:r>
            </a:p>
          </p:txBody>
        </p:sp>
      </p:grpSp>
      <p:pic>
        <p:nvPicPr>
          <p:cNvPr id="11" name="Picture 13">
            <a:extLst>
              <a:ext uri="{FF2B5EF4-FFF2-40B4-BE49-F238E27FC236}">
                <a16:creationId xmlns:a16="http://schemas.microsoft.com/office/drawing/2014/main" id="{542E91A0-7EBA-452D-A63D-9CC0BE694B4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8619" y="4598865"/>
            <a:ext cx="11771811" cy="873663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12" name="Rectangle 26">
            <a:extLst>
              <a:ext uri="{FF2B5EF4-FFF2-40B4-BE49-F238E27FC236}">
                <a16:creationId xmlns:a16="http://schemas.microsoft.com/office/drawing/2014/main" id="{74EC4D41-0328-4EF9-811E-15A76F59FBA5}"/>
              </a:ext>
            </a:extLst>
          </p:cNvPr>
          <p:cNvSpPr/>
          <p:nvPr/>
        </p:nvSpPr>
        <p:spPr>
          <a:xfrm>
            <a:off x="5458693" y="3200070"/>
            <a:ext cx="3140360" cy="1141015"/>
          </a:xfrm>
          <a:prstGeom prst="rect">
            <a:avLst/>
          </a:prstGeom>
          <a:noFill/>
          <a:ln w="44448" cap="flat">
            <a:solidFill>
              <a:srgbClr val="000000"/>
            </a:solidFill>
            <a:custDash>
              <a:ds d="100000" sp="100000"/>
            </a:custDash>
            <a:miter/>
          </a:ln>
        </p:spPr>
        <p:txBody>
          <a:bodyPr vert="horz" wrap="square" lIns="91440" tIns="45720" rIns="91440" bIns="45720" anchor="ctr" anchorCtr="1" compatLnSpc="1">
            <a:no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800" b="0" i="0" u="none" strike="noStrike" kern="1200" cap="none" spc="0" baseline="0">
              <a:solidFill>
                <a:srgbClr val="FFFFFF"/>
              </a:solidFill>
              <a:uFillTx/>
              <a:latin typeface="Calibri"/>
            </a:endParaRPr>
          </a:p>
        </p:txBody>
      </p:sp>
      <p:cxnSp>
        <p:nvCxnSpPr>
          <p:cNvPr id="13" name="Straight Arrow Connector 34">
            <a:extLst>
              <a:ext uri="{FF2B5EF4-FFF2-40B4-BE49-F238E27FC236}">
                <a16:creationId xmlns:a16="http://schemas.microsoft.com/office/drawing/2014/main" id="{9FDF1D14-8A4D-47AA-BC7C-CBBFAC4B2E73}"/>
              </a:ext>
            </a:extLst>
          </p:cNvPr>
          <p:cNvCxnSpPr/>
          <p:nvPr/>
        </p:nvCxnSpPr>
        <p:spPr>
          <a:xfrm>
            <a:off x="5458693" y="4341086"/>
            <a:ext cx="1408268" cy="637309"/>
          </a:xfrm>
          <a:prstGeom prst="straightConnector1">
            <a:avLst/>
          </a:prstGeom>
          <a:noFill/>
          <a:ln w="19046" cap="flat">
            <a:solidFill>
              <a:srgbClr val="000000"/>
            </a:solidFill>
            <a:prstDash val="solid"/>
            <a:miter/>
            <a:tailEnd type="arrow"/>
          </a:ln>
        </p:spPr>
      </p:cxnSp>
      <p:cxnSp>
        <p:nvCxnSpPr>
          <p:cNvPr id="14" name="Straight Arrow Connector 36">
            <a:extLst>
              <a:ext uri="{FF2B5EF4-FFF2-40B4-BE49-F238E27FC236}">
                <a16:creationId xmlns:a16="http://schemas.microsoft.com/office/drawing/2014/main" id="{5DE94A18-2D6B-4CAC-B42E-455F268D73DC}"/>
              </a:ext>
            </a:extLst>
          </p:cNvPr>
          <p:cNvCxnSpPr/>
          <p:nvPr/>
        </p:nvCxnSpPr>
        <p:spPr>
          <a:xfrm flipH="1">
            <a:off x="6419270" y="4341086"/>
            <a:ext cx="2179784" cy="643290"/>
          </a:xfrm>
          <a:prstGeom prst="straightConnector1">
            <a:avLst/>
          </a:prstGeom>
          <a:noFill/>
          <a:ln w="19046" cap="flat">
            <a:solidFill>
              <a:srgbClr val="000000"/>
            </a:solidFill>
            <a:prstDash val="solid"/>
            <a:miter/>
            <a:tailEnd type="arrow"/>
          </a:ln>
        </p:spPr>
      </p:cxnSp>
      <p:sp>
        <p:nvSpPr>
          <p:cNvPr id="15" name="TextBox 37">
            <a:extLst>
              <a:ext uri="{FF2B5EF4-FFF2-40B4-BE49-F238E27FC236}">
                <a16:creationId xmlns:a16="http://schemas.microsoft.com/office/drawing/2014/main" id="{2F9DDBC4-E158-459B-A1AA-50ED08C5A1E1}"/>
              </a:ext>
            </a:extLst>
          </p:cNvPr>
          <p:cNvSpPr txBox="1"/>
          <p:nvPr/>
        </p:nvSpPr>
        <p:spPr>
          <a:xfrm>
            <a:off x="258619" y="5753532"/>
            <a:ext cx="11656286" cy="861776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0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Top track shows the O-antigen locus and surrounding genes for the reference sequence for serotype O89 (NCTC9089). The locus is shown in green between the capsule (pink) and </a:t>
            </a:r>
            <a:r>
              <a:rPr lang="en-GB" sz="10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his</a:t>
            </a:r>
            <a:r>
              <a:rPr lang="en-GB" sz="10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genes (red).</a:t>
            </a: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0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Middle track shows alignment of corresponding O-antigen genes in ec_26561. The aligned region stretches from </a:t>
            </a:r>
            <a:r>
              <a:rPr lang="en-GB" sz="10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wcaM</a:t>
            </a:r>
            <a:r>
              <a:rPr lang="en-GB" sz="10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(upstream </a:t>
            </a:r>
            <a:r>
              <a:rPr lang="en-GB" sz="10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of galF </a:t>
            </a:r>
            <a:r>
              <a:rPr lang="en-GB" sz="1000" b="0" i="0" u="none" strike="noStrike" kern="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(grey))</a:t>
            </a:r>
            <a:r>
              <a:rPr lang="en-GB" sz="10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, which is the last gene of the colanic acid </a:t>
            </a:r>
            <a:r>
              <a:rPr lang="en-GB" sz="1000" b="0" i="0" u="none" strike="noStrike" kern="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locus</a:t>
            </a:r>
            <a:r>
              <a:rPr lang="en-GB" sz="10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, and continues to the first 22 amino-acids of the </a:t>
            </a:r>
            <a:r>
              <a:rPr lang="en-GB" sz="10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gnd</a:t>
            </a:r>
            <a:r>
              <a:rPr lang="en-GB" sz="10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gene.</a:t>
            </a: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0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The bottom track shows </a:t>
            </a:r>
            <a:r>
              <a:rPr lang="en-GB" sz="1000" b="0" i="0" u="none" strike="noStrike" kern="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the </a:t>
            </a:r>
            <a:r>
              <a:rPr lang="en-GB" sz="10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E.coli</a:t>
            </a:r>
            <a:r>
              <a:rPr lang="en-GB" sz="10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K12 region (from </a:t>
            </a:r>
            <a:r>
              <a:rPr lang="en-GB" sz="1000" b="0" i="0" u="none" strike="noStrike" kern="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EcoCyc.org, https://doi.org/10.1093/nar/gkw1003) where </a:t>
            </a:r>
            <a:r>
              <a:rPr lang="en-GB" sz="10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the o-antigen </a:t>
            </a:r>
            <a:r>
              <a:rPr lang="en-GB" sz="1000" b="0" i="0" u="none" strike="noStrike" kern="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is found </a:t>
            </a:r>
            <a:r>
              <a:rPr lang="en-GB" sz="10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in ec</a:t>
            </a:r>
            <a:r>
              <a:rPr lang="en-GB" sz="1000" b="0" i="0" u="none" strike="noStrike" kern="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26561, between </a:t>
            </a:r>
            <a:r>
              <a:rPr lang="en-GB" sz="1000" b="0" i="1" u="none" strike="noStrike" kern="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ybdK</a:t>
            </a:r>
            <a:r>
              <a:rPr lang="en-GB" sz="1000" b="0" i="0" u="none" strike="noStrike" kern="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and </a:t>
            </a:r>
            <a:r>
              <a:rPr lang="en-GB" sz="1000" b="0" i="1" u="none" strike="noStrike" kern="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nfsB</a:t>
            </a:r>
            <a:r>
              <a:rPr lang="en-GB" sz="1000" b="0" i="0" u="none" strike="noStrike" kern="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.</a:t>
            </a:r>
            <a:r>
              <a:rPr lang="en-GB" sz="10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 Two genes; </a:t>
            </a:r>
            <a:r>
              <a:rPr lang="en-GB" sz="1000" b="0" i="1" u="none" strike="noStrike" kern="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y</a:t>
            </a:r>
            <a:r>
              <a:rPr lang="en-GB" sz="10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bdJ</a:t>
            </a:r>
            <a:r>
              <a:rPr lang="en-GB" sz="10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and </a:t>
            </a:r>
            <a:r>
              <a:rPr lang="en-GB" sz="10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ybdF</a:t>
            </a:r>
            <a:r>
              <a:rPr lang="en-GB" sz="10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from K12 are missing in our </a:t>
            </a:r>
            <a:r>
              <a:rPr lang="en-GB" sz="1000" b="0" i="0" u="none" strike="noStrike" kern="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O89m </a:t>
            </a:r>
            <a:r>
              <a:rPr lang="en-GB" sz="10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strains</a:t>
            </a:r>
            <a:r>
              <a:rPr lang="en-GB" sz="1000" b="0" i="0" u="none" strike="noStrike" kern="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(next slide).</a:t>
            </a:r>
            <a:endParaRPr lang="en-GB" sz="1000" b="0" i="0" u="none" strike="noStrike" kern="1200" cap="none" spc="0" baseline="0">
              <a:solidFill>
                <a:srgbClr val="000000"/>
              </a:solidFill>
              <a:uFillTx/>
              <a:latin typeface="Times New Roman" pitchFamily="18"/>
              <a:cs typeface="Times New Roman" pitchFamily="18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9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0">
            <a:extLst>
              <a:ext uri="{FF2B5EF4-FFF2-40B4-BE49-F238E27FC236}">
                <a16:creationId xmlns:a16="http://schemas.microsoft.com/office/drawing/2014/main" id="{E607D30A-9E4D-4548-B72E-538D0A7AE705}"/>
              </a:ext>
            </a:extLst>
          </p:cNvPr>
          <p:cNvGrpSpPr/>
          <p:nvPr/>
        </p:nvGrpSpPr>
        <p:grpSpPr>
          <a:xfrm>
            <a:off x="480288" y="1799667"/>
            <a:ext cx="11399550" cy="1356750"/>
            <a:chOff x="480288" y="1799667"/>
            <a:chExt cx="11399550" cy="1356750"/>
          </a:xfrm>
        </p:grpSpPr>
        <p:sp>
          <p:nvSpPr>
            <p:cNvPr id="3" name="TextBox 3">
              <a:extLst>
                <a:ext uri="{FF2B5EF4-FFF2-40B4-BE49-F238E27FC236}">
                  <a16:creationId xmlns:a16="http://schemas.microsoft.com/office/drawing/2014/main" id="{FB96DCC0-86BD-4531-AA5C-736051DBACB8}"/>
                </a:ext>
              </a:extLst>
            </p:cNvPr>
            <p:cNvSpPr txBox="1"/>
            <p:nvPr/>
          </p:nvSpPr>
          <p:spPr>
            <a:xfrm>
              <a:off x="5572161" y="2879418"/>
              <a:ext cx="4009031" cy="276999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200" b="0" i="0" u="none" strike="noStrike" kern="1200" cap="none" spc="0" baseline="0">
                  <a:solidFill>
                    <a:srgbClr val="000000"/>
                  </a:solidFill>
                  <a:uFillTx/>
                  <a:latin typeface="Times New Roman" pitchFamily="18"/>
                  <a:cs typeface="Times New Roman" pitchFamily="18"/>
                </a:rPr>
                <a:t>K12 genes replaced by O-antigen cluster</a:t>
              </a:r>
            </a:p>
          </p:txBody>
        </p:sp>
        <p:grpSp>
          <p:nvGrpSpPr>
            <p:cNvPr id="4" name="Group 9">
              <a:extLst>
                <a:ext uri="{FF2B5EF4-FFF2-40B4-BE49-F238E27FC236}">
                  <a16:creationId xmlns:a16="http://schemas.microsoft.com/office/drawing/2014/main" id="{208899E8-83E2-4B1A-AE1C-8F257A2CD438}"/>
                </a:ext>
              </a:extLst>
            </p:cNvPr>
            <p:cNvGrpSpPr/>
            <p:nvPr/>
          </p:nvGrpSpPr>
          <p:grpSpPr>
            <a:xfrm>
              <a:off x="480288" y="1799667"/>
              <a:ext cx="11399550" cy="972821"/>
              <a:chOff x="480288" y="1799667"/>
              <a:chExt cx="11399550" cy="972821"/>
            </a:xfrm>
          </p:grpSpPr>
          <p:pic>
            <p:nvPicPr>
              <p:cNvPr id="5" name="Picture 1">
                <a:extLst>
                  <a:ext uri="{FF2B5EF4-FFF2-40B4-BE49-F238E27FC236}">
                    <a16:creationId xmlns:a16="http://schemas.microsoft.com/office/drawing/2014/main" id="{5C9B46F3-5C81-45F0-B4A2-CA9157D70CF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80288" y="1799667"/>
                <a:ext cx="11399550" cy="972821"/>
              </a:xfrm>
              <a:prstGeom prst="rect">
                <a:avLst/>
              </a:prstGeom>
              <a:noFill/>
              <a:ln cap="flat">
                <a:noFill/>
              </a:ln>
            </p:spPr>
          </p:pic>
          <p:sp>
            <p:nvSpPr>
              <p:cNvPr id="6" name="Rectangle 7">
                <a:extLst>
                  <a:ext uri="{FF2B5EF4-FFF2-40B4-BE49-F238E27FC236}">
                    <a16:creationId xmlns:a16="http://schemas.microsoft.com/office/drawing/2014/main" id="{CD8363F9-F76E-4B22-81A2-2CB3C43D1722}"/>
                  </a:ext>
                </a:extLst>
              </p:cNvPr>
              <p:cNvSpPr/>
              <p:nvPr/>
            </p:nvSpPr>
            <p:spPr>
              <a:xfrm>
                <a:off x="6180063" y="1906597"/>
                <a:ext cx="1033537" cy="865891"/>
              </a:xfrm>
              <a:prstGeom prst="rect">
                <a:avLst/>
              </a:prstGeom>
              <a:noFill/>
              <a:ln w="31747" cap="flat">
                <a:solidFill>
                  <a:srgbClr val="000000"/>
                </a:solidFill>
                <a:prstDash val="solid"/>
                <a:miter/>
              </a:ln>
            </p:spPr>
            <p:txBody>
              <a:bodyPr vert="horz" wrap="square" lIns="91440" tIns="45720" rIns="91440" bIns="45720" anchor="ctr" anchorCtr="1" compatLnSpc="1">
                <a:noAutofit/>
              </a:bodyPr>
              <a:lstStyle/>
              <a:p>
                <a:pPr marL="0" marR="0" lvl="0" indent="0" algn="ctr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en-GB" sz="1800" b="0" i="0" u="none" strike="noStrike" kern="1200" cap="none" spc="0" baseline="0">
                  <a:solidFill>
                    <a:srgbClr val="FFFFFF"/>
                  </a:solidFill>
                  <a:uFillTx/>
                  <a:latin typeface="Calibri"/>
                </a:endParaRPr>
              </a:p>
            </p:txBody>
          </p:sp>
        </p:grp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4A47BA5E-06BF-4A8F-974A-0BD58760C9BE}"/>
              </a:ext>
            </a:extLst>
          </p:cNvPr>
          <p:cNvSpPr txBox="1"/>
          <p:nvPr/>
        </p:nvSpPr>
        <p:spPr>
          <a:xfrm>
            <a:off x="692731" y="3636934"/>
            <a:ext cx="9522689" cy="1015660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In </a:t>
            </a:r>
            <a:r>
              <a:rPr lang="en-GB" sz="12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E.coli </a:t>
            </a:r>
            <a:r>
              <a: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26561 the O89m locus is located between the </a:t>
            </a:r>
            <a:r>
              <a:rPr lang="en-GB" sz="12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ybdK</a:t>
            </a:r>
            <a:r>
              <a: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and </a:t>
            </a:r>
            <a:r>
              <a:rPr lang="en-GB" sz="12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nfsB</a:t>
            </a:r>
            <a:r>
              <a: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genes. In </a:t>
            </a:r>
            <a:r>
              <a:rPr lang="en-GB" sz="12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E.coli </a:t>
            </a:r>
            <a:r>
              <a: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K12 this space is occupied by </a:t>
            </a:r>
            <a:r>
              <a:rPr lang="en-GB" sz="12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ybdJ</a:t>
            </a:r>
            <a:r>
              <a: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and </a:t>
            </a:r>
            <a:r>
              <a:rPr lang="en-GB" sz="12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ybdF</a:t>
            </a:r>
            <a:r>
              <a: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genes; both are described as hypothetical proteins. The 91 bp region between </a:t>
            </a:r>
            <a:r>
              <a:rPr lang="en-GB" sz="12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ybdF and </a:t>
            </a:r>
            <a:r>
              <a: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the downstream gene </a:t>
            </a:r>
            <a:r>
              <a:rPr lang="en-GB" sz="12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nfsB</a:t>
            </a:r>
            <a:r>
              <a: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in K12 was aligned to the corresponding bases upstream of </a:t>
            </a:r>
            <a:r>
              <a:rPr lang="en-GB" sz="12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nfsB</a:t>
            </a:r>
            <a:r>
              <a: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in 26561; there is a 100% match and so the binding site of the transcriptional regulator </a:t>
            </a:r>
            <a:r>
              <a:rPr lang="en-GB" sz="12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marA</a:t>
            </a:r>
            <a:r>
              <a: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, which occurs 43 bases upstream of </a:t>
            </a:r>
            <a:r>
              <a:rPr lang="en-GB" sz="1200" b="0" i="1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nfsB</a:t>
            </a:r>
            <a:r>
              <a: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cs typeface="Times New Roman" pitchFamily="18"/>
              </a:rPr>
              <a:t> in K12 (shown as small green bar) appears to be unaffected by the insertion.</a:t>
            </a: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200" b="0" i="0" u="none" strike="noStrike" kern="1200" cap="none" spc="0" baseline="0">
              <a:solidFill>
                <a:srgbClr val="000000"/>
              </a:solidFill>
              <a:uFillTx/>
              <a:latin typeface="Times New Roman" pitchFamily="18"/>
              <a:cs typeface="Times New Roman" pitchFamily="18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66</TotalTime>
  <Words>306</Words>
  <Application>Microsoft Office PowerPoint</Application>
  <PresentationFormat>Widescreen</PresentationFormat>
  <Paragraphs>15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Reference 089 serotype aligned to ‘O89m’ in E.coli 26561 and genomic location of ‘O89m’ in relation to E.coli-K12 MG1655.</vt:lpstr>
      <vt:lpstr>E.coli NCTC9089 vs. 26561 vs. E.coli K12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 Harris</dc:creator>
  <cp:lastModifiedBy>DGES</cp:lastModifiedBy>
  <cp:revision>24</cp:revision>
  <cp:lastPrinted>2017-04-19T14:22:30Z</cp:lastPrinted>
  <dcterms:created xsi:type="dcterms:W3CDTF">2017-04-03T15:54:51Z</dcterms:created>
  <dcterms:modified xsi:type="dcterms:W3CDTF">2018-05-18T10:00:32Z</dcterms:modified>
</cp:coreProperties>
</file>